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  <p:sldMasterId id="2147483657" r:id="rId2"/>
  </p:sldMasterIdLst>
  <p:notesMasterIdLst>
    <p:notesMasterId r:id="rId19"/>
  </p:notesMasterIdLst>
  <p:sldIdLst>
    <p:sldId id="661" r:id="rId3"/>
    <p:sldId id="2071591636" r:id="rId4"/>
    <p:sldId id="628" r:id="rId5"/>
    <p:sldId id="662" r:id="rId6"/>
    <p:sldId id="673" r:id="rId7"/>
    <p:sldId id="674" r:id="rId8"/>
    <p:sldId id="2071591625" r:id="rId9"/>
    <p:sldId id="667" r:id="rId10"/>
    <p:sldId id="666" r:id="rId11"/>
    <p:sldId id="665" r:id="rId12"/>
    <p:sldId id="2071591638" r:id="rId13"/>
    <p:sldId id="640" r:id="rId14"/>
    <p:sldId id="2071591634" r:id="rId15"/>
    <p:sldId id="2071591635" r:id="rId16"/>
    <p:sldId id="369" r:id="rId17"/>
    <p:sldId id="2071591637" r:id="rId18"/>
  </p:sldIdLst>
  <p:sldSz cx="9144000" cy="5715000" type="screen16x1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46565E"/>
    <a:srgbClr val="025358"/>
    <a:srgbClr val="62B4A8"/>
    <a:srgbClr val="F8F8F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98" d="100"/>
          <a:sy n="98" d="100"/>
        </p:scale>
        <p:origin x="60" y="2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slide" Target="slides/slide11.xml"/><Relationship Id="rId18" Type="http://schemas.openxmlformats.org/officeDocument/2006/relationships/slide" Target="slides/slide16.xml"/><Relationship Id="rId3" Type="http://schemas.openxmlformats.org/officeDocument/2006/relationships/slide" Target="slides/slide1.xml"/><Relationship Id="rId21" Type="http://schemas.openxmlformats.org/officeDocument/2006/relationships/viewProps" Target="viewProps.xml"/><Relationship Id="rId7" Type="http://schemas.openxmlformats.org/officeDocument/2006/relationships/slide" Target="slides/slide5.xml"/><Relationship Id="rId12" Type="http://schemas.openxmlformats.org/officeDocument/2006/relationships/slide" Target="slides/slide10.xml"/><Relationship Id="rId17" Type="http://schemas.openxmlformats.org/officeDocument/2006/relationships/slide" Target="slides/slide15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4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5" Type="http://schemas.openxmlformats.org/officeDocument/2006/relationships/slide" Target="slides/slide3.xml"/><Relationship Id="rId15" Type="http://schemas.openxmlformats.org/officeDocument/2006/relationships/slide" Target="slides/slide13.xml"/><Relationship Id="rId23" Type="http://schemas.openxmlformats.org/officeDocument/2006/relationships/tableStyles" Target="tableStyles.xml"/><Relationship Id="rId10" Type="http://schemas.openxmlformats.org/officeDocument/2006/relationships/slide" Target="slides/slide8.xml"/><Relationship Id="rId19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slide" Target="slides/slide12.xml"/><Relationship Id="rId22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DB6CCA-7F7E-434F-B0B8-B2974673B53D}" type="datetimeFigureOut">
              <a:rPr lang="zh-CN" altLang="en-US" smtClean="0"/>
              <a:t>2024/11/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960438" y="1143000"/>
            <a:ext cx="49371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C7E137-9776-4320-9448-0CE0DB3405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90472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2.xml"/><Relationship Id="rId4" Type="http://schemas.openxmlformats.org/officeDocument/2006/relationships/image" Target="../media/image4.svg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2.xml"/><Relationship Id="rId4" Type="http://schemas.openxmlformats.org/officeDocument/2006/relationships/image" Target="../media/image4.svg"/></Relationships>
</file>

<file path=ppt/slideLayouts/_rels/slideLayout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2.xml"/><Relationship Id="rId4" Type="http://schemas.openxmlformats.org/officeDocument/2006/relationships/image" Target="../media/image4.svg"/></Relationships>
</file>

<file path=ppt/slideLayouts/_rels/slideLayout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sv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2.xml"/><Relationship Id="rId5" Type="http://schemas.openxmlformats.org/officeDocument/2006/relationships/image" Target="../media/image4.svg"/><Relationship Id="rId4" Type="http://schemas.openxmlformats.org/officeDocument/2006/relationships/image" Target="../media/image3.png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和副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</p:nvPr>
        </p:nvSpPr>
        <p:spPr>
          <a:xfrm>
            <a:off x="502412" y="1924068"/>
            <a:ext cx="8139178" cy="749306"/>
          </a:xfrm>
        </p:spPr>
        <p:txBody>
          <a:bodyPr lIns="101600" tIns="38100" rIns="25400" bIns="38100" anchor="t" anchorCtr="0">
            <a:noAutofit/>
          </a:bodyPr>
          <a:lstStyle>
            <a:lvl1pPr algn="ctr">
              <a:defRPr sz="4050" b="0" spc="600">
                <a:effectLst/>
                <a:latin typeface="+mn-ea"/>
                <a:ea typeface="+mn-ea"/>
              </a:defRPr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</p:nvPr>
        </p:nvSpPr>
        <p:spPr>
          <a:xfrm>
            <a:off x="502444" y="2971271"/>
            <a:ext cx="8139113" cy="667808"/>
          </a:xfrm>
        </p:spPr>
        <p:txBody>
          <a:bodyPr lIns="101600" tIns="38100" rIns="76200" bIns="38100" anchor="ctr" anchorCtr="0">
            <a:noAutofit/>
          </a:bodyPr>
          <a:lstStyle>
            <a:lvl1pPr marL="0" indent="0" algn="ctr" eaLnBrk="1" fontAlgn="auto" latinLnBrk="0" hangingPunct="1">
              <a:lnSpc>
                <a:spcPct val="100000"/>
              </a:lnSpc>
              <a:buNone/>
              <a:defRPr sz="1800" u="none" strike="noStrike" kern="1200" cap="none" spc="200" normalizeH="0" baseline="0">
                <a:solidFill>
                  <a:schemeClr val="tx1"/>
                </a:solidFill>
                <a:uFillTx/>
                <a:latin typeface="+mn-ea"/>
                <a:ea typeface="+mn-ea"/>
              </a:defRPr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dirty="0"/>
              <a:t>单击此处编辑副标题</a:t>
            </a:r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+mn-ea"/>
              </a:defRPr>
            </a:lvl1pPr>
          </a:lstStyle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+mn-ea"/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8650" y="1019213"/>
            <a:ext cx="7886700" cy="758788"/>
          </a:xfrm>
          <a:prstGeom prst="rect">
            <a:avLst/>
          </a:prstGeo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>
          <a:xfrm>
            <a:off x="628650" y="1821922"/>
            <a:ext cx="7886700" cy="3084512"/>
          </a:xfrm>
          <a:prstGeom prst="rect">
            <a:avLst/>
          </a:prstGeo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pic>
        <p:nvPicPr>
          <p:cNvPr id="9" name="图片 8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80867" y="5246787"/>
            <a:ext cx="1144186" cy="312469"/>
          </a:xfrm>
          <a:prstGeom prst="rect">
            <a:avLst/>
          </a:prstGeom>
        </p:spPr>
      </p:pic>
      <p:pic>
        <p:nvPicPr>
          <p:cNvPr id="10" name="图形 9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324836" y="5191114"/>
            <a:ext cx="1688289" cy="287777"/>
          </a:xfrm>
          <a:prstGeom prst="rect">
            <a:avLst/>
          </a:prstGeom>
        </p:spPr>
      </p:pic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8650" y="1217995"/>
            <a:ext cx="7886700" cy="784114"/>
          </a:xfrm>
          <a:prstGeom prst="rect">
            <a:avLst/>
          </a:prstGeo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628649" y="2114557"/>
            <a:ext cx="3901017" cy="2974445"/>
          </a:xfrm>
          <a:prstGeom prst="rect">
            <a:avLst/>
          </a:prstGeo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4629149" y="2114557"/>
            <a:ext cx="3901017" cy="2974446"/>
          </a:xfrm>
          <a:prstGeom prst="rect">
            <a:avLst/>
          </a:prstGeo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pic>
        <p:nvPicPr>
          <p:cNvPr id="10" name="图片 9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80867" y="5246787"/>
            <a:ext cx="1144186" cy="312469"/>
          </a:xfrm>
          <a:prstGeom prst="rect">
            <a:avLst/>
          </a:prstGeom>
        </p:spPr>
      </p:pic>
      <p:pic>
        <p:nvPicPr>
          <p:cNvPr id="11" name="图形 10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324836" y="5191114"/>
            <a:ext cx="1688289" cy="287777"/>
          </a:xfrm>
          <a:prstGeom prst="rect">
            <a:avLst/>
          </a:prstGeom>
        </p:spPr>
      </p:pic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931215"/>
            <a:ext cx="7886700" cy="669245"/>
          </a:xfrm>
          <a:prstGeom prst="rect">
            <a:avLst/>
          </a:prstGeo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629841" y="1740558"/>
            <a:ext cx="3887391" cy="39846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629842" y="2279117"/>
            <a:ext cx="3868340" cy="2810404"/>
          </a:xfrm>
          <a:prstGeom prst="rect">
            <a:avLst/>
          </a:prstGeo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629150" y="1740558"/>
            <a:ext cx="3906536" cy="39846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 hasCustomPrompt="1"/>
          </p:nvPr>
        </p:nvSpPr>
        <p:spPr>
          <a:xfrm>
            <a:off x="4629150" y="2279117"/>
            <a:ext cx="3887391" cy="2810404"/>
          </a:xfrm>
          <a:prstGeom prst="rect">
            <a:avLst/>
          </a:prstGeo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pic>
        <p:nvPicPr>
          <p:cNvPr id="12" name="图片 11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80867" y="5246787"/>
            <a:ext cx="1144186" cy="312469"/>
          </a:xfrm>
          <a:prstGeom prst="rect">
            <a:avLst/>
          </a:prstGeom>
        </p:spPr>
      </p:pic>
      <p:pic>
        <p:nvPicPr>
          <p:cNvPr id="13" name="图形 12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324836" y="5191114"/>
            <a:ext cx="1688289" cy="287777"/>
          </a:xfrm>
          <a:prstGeom prst="rect">
            <a:avLst/>
          </a:prstGeom>
        </p:spPr>
      </p:pic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8650" y="3141132"/>
            <a:ext cx="7886700" cy="646907"/>
          </a:xfrm>
          <a:prstGeom prst="rect">
            <a:avLst/>
          </a:prstGeom>
        </p:spPr>
        <p:txBody>
          <a:bodyPr/>
          <a:lstStyle>
            <a:lvl1pPr algn="ctr">
              <a:defRPr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pic>
        <p:nvPicPr>
          <p:cNvPr id="6" name="图形 5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3204001" y="1451201"/>
            <a:ext cx="2735997" cy="811779"/>
          </a:xfrm>
          <a:prstGeom prst="rect">
            <a:avLst/>
          </a:prstGeom>
        </p:spPr>
      </p:pic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3672417"/>
            <a:ext cx="7772400" cy="1135063"/>
          </a:xfrm>
        </p:spPr>
        <p:txBody>
          <a:bodyPr anchor="t"/>
          <a:lstStyle>
            <a:lvl1pPr algn="l">
              <a:defRPr sz="3333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422261"/>
            <a:ext cx="7772400" cy="1250156"/>
          </a:xfrm>
        </p:spPr>
        <p:txBody>
          <a:bodyPr anchor="b"/>
          <a:lstStyle>
            <a:lvl1pPr marL="0" indent="0">
              <a:buNone/>
              <a:defRPr sz="1667">
                <a:solidFill>
                  <a:schemeClr val="tx1">
                    <a:tint val="75000"/>
                  </a:schemeClr>
                </a:solidFill>
              </a:defRPr>
            </a:lvl1pPr>
            <a:lvl2pPr marL="38098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761970" indent="0">
              <a:buNone/>
              <a:defRPr sz="1333">
                <a:solidFill>
                  <a:schemeClr val="tx1">
                    <a:tint val="75000"/>
                  </a:schemeClr>
                </a:solidFill>
              </a:defRPr>
            </a:lvl3pPr>
            <a:lvl4pPr marL="1142954" indent="0">
              <a:buNone/>
              <a:defRPr sz="1167">
                <a:solidFill>
                  <a:schemeClr val="tx1">
                    <a:tint val="75000"/>
                  </a:schemeClr>
                </a:solidFill>
              </a:defRPr>
            </a:lvl4pPr>
            <a:lvl5pPr marL="1523939" indent="0">
              <a:buNone/>
              <a:defRPr sz="1167">
                <a:solidFill>
                  <a:schemeClr val="tx1">
                    <a:tint val="75000"/>
                  </a:schemeClr>
                </a:solidFill>
              </a:defRPr>
            </a:lvl5pPr>
            <a:lvl6pPr marL="1904924" indent="0">
              <a:buNone/>
              <a:defRPr sz="1167">
                <a:solidFill>
                  <a:schemeClr val="tx1">
                    <a:tint val="75000"/>
                  </a:schemeClr>
                </a:solidFill>
              </a:defRPr>
            </a:lvl6pPr>
            <a:lvl7pPr marL="2285909" indent="0">
              <a:buNone/>
              <a:defRPr sz="1167">
                <a:solidFill>
                  <a:schemeClr val="tx1">
                    <a:tint val="75000"/>
                  </a:schemeClr>
                </a:solidFill>
              </a:defRPr>
            </a:lvl7pPr>
            <a:lvl8pPr marL="2666893" indent="0">
              <a:buNone/>
              <a:defRPr sz="1167">
                <a:solidFill>
                  <a:schemeClr val="tx1">
                    <a:tint val="75000"/>
                  </a:schemeClr>
                </a:solidFill>
              </a:defRPr>
            </a:lvl8pPr>
            <a:lvl9pPr marL="3047878" indent="0">
              <a:buNone/>
              <a:defRPr sz="11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164866-69AF-462E-9C5C-CFA4BC149319}" type="datetimeFigureOut">
              <a:rPr lang="en-US" smtClean="0"/>
              <a:pPr/>
              <a:t>11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33C408-CCB0-4791-AC1C-E8A051BB586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4360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正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</p:nvPr>
        </p:nvSpPr>
        <p:spPr>
          <a:xfrm>
            <a:off x="502412" y="484354"/>
            <a:ext cx="8139178" cy="540000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4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n-ea"/>
                <a:ea typeface="+mn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标题</a:t>
            </a: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+mn-ea"/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+mn-ea"/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idx="1" hasCustomPrompt="1"/>
          </p:nvPr>
        </p:nvSpPr>
        <p:spPr>
          <a:xfrm>
            <a:off x="502444" y="1256771"/>
            <a:ext cx="8139113" cy="3957638"/>
          </a:xfrm>
          <a:prstGeom prst="rect">
            <a:avLst/>
          </a:prstGeom>
        </p:spPr>
        <p:txBody>
          <a:bodyPr vert="horz" lIns="101600" tIns="0" rIns="82550" bIns="0" rtlCol="0">
            <a:normAutofit/>
          </a:bodyPr>
          <a:lstStyle>
            <a:lvl1pPr>
              <a:defRPr sz="18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</a:lstStyle>
          <a:p>
            <a:pPr lvl="0"/>
            <a:r>
              <a:rPr lang="zh-CN" altLang="en-US" dirty="0"/>
              <a:t>单击此处编辑正文</a:t>
            </a:r>
          </a:p>
          <a:p>
            <a:pPr lvl="0"/>
            <a:r>
              <a:rPr lang="zh-CN" altLang="en-US" dirty="0">
                <a:sym typeface="+mn-ea"/>
              </a:rPr>
              <a:t>单击此处编辑正文</a:t>
            </a:r>
            <a:endParaRPr lang="zh-CN" altLang="en-US" dirty="0"/>
          </a:p>
          <a:p>
            <a:pPr lvl="0"/>
            <a:r>
              <a:rPr lang="zh-CN" altLang="en-US" dirty="0">
                <a:sym typeface="+mn-ea"/>
              </a:rPr>
              <a:t>单击此处编辑正文</a:t>
            </a:r>
            <a:endParaRPr lang="zh-CN" altLang="en-US" dirty="0"/>
          </a:p>
          <a:p>
            <a:pPr lvl="0"/>
            <a:r>
              <a:rPr lang="zh-CN" altLang="en-US" dirty="0">
                <a:sym typeface="+mn-ea"/>
              </a:rPr>
              <a:t>单击此处编辑正文</a:t>
            </a:r>
            <a:endParaRPr lang="zh-CN" altLang="en-US" dirty="0"/>
          </a:p>
          <a:p>
            <a:pPr lvl="0"/>
            <a:r>
              <a:rPr lang="zh-CN" altLang="en-US" dirty="0">
                <a:sym typeface="+mn-ea"/>
              </a:rPr>
              <a:t>单击此处编辑正文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标题与图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+mn-ea"/>
              </a:defRPr>
            </a:lvl1pPr>
          </a:lstStyle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+mn-ea"/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5" name="标题 4"/>
          <p:cNvSpPr>
            <a:spLocks noGrp="1"/>
          </p:cNvSpPr>
          <p:nvPr>
            <p:ph type="title" hasCustomPrompt="1"/>
          </p:nvPr>
        </p:nvSpPr>
        <p:spPr>
          <a:xfrm>
            <a:off x="630079" y="606425"/>
            <a:ext cx="2948940" cy="929217"/>
          </a:xfrm>
        </p:spPr>
        <p:txBody>
          <a:bodyPr anchor="ctr" anchorCtr="0"/>
          <a:lstStyle>
            <a:lvl1pPr>
              <a:defRPr sz="2400">
                <a:latin typeface="+mn-ea"/>
                <a:ea typeface="+mn-ea"/>
              </a:defRPr>
            </a:lvl1pPr>
          </a:lstStyle>
          <a:p>
            <a:r>
              <a:rPr lang="zh-CN" altLang="en-US"/>
              <a:t>单击此处编辑标题</a:t>
            </a:r>
          </a:p>
        </p:txBody>
      </p:sp>
      <p:sp>
        <p:nvSpPr>
          <p:cNvPr id="6" name="内容占位符 5"/>
          <p:cNvSpPr>
            <a:spLocks noGrp="1"/>
          </p:cNvSpPr>
          <p:nvPr>
            <p:ph idx="1" hasCustomPrompt="1"/>
          </p:nvPr>
        </p:nvSpPr>
        <p:spPr>
          <a:xfrm>
            <a:off x="3853815" y="606425"/>
            <a:ext cx="4629150" cy="4502679"/>
          </a:xfrm>
        </p:spPr>
        <p:txBody>
          <a:bodyPr/>
          <a:lstStyle>
            <a:lvl1pPr>
              <a:defRPr sz="1800">
                <a:latin typeface="+mn-ea"/>
                <a:ea typeface="+mn-ea"/>
              </a:defRPr>
            </a:lvl1pPr>
            <a:lvl2pPr marL="342900" indent="0">
              <a:buNone/>
              <a:defRPr sz="1800">
                <a:latin typeface="+mn-ea"/>
                <a:ea typeface="+mn-ea"/>
              </a:defRPr>
            </a:lvl2pPr>
            <a:lvl3pPr>
              <a:defRPr sz="1800">
                <a:latin typeface="+mn-ea"/>
                <a:ea typeface="+mn-ea"/>
              </a:defRPr>
            </a:lvl3pPr>
            <a:lvl4pPr>
              <a:defRPr sz="1800">
                <a:latin typeface="+mn-ea"/>
                <a:ea typeface="+mn-ea"/>
              </a:defRPr>
            </a:lvl4pPr>
            <a:lvl5pPr>
              <a:defRPr sz="1800">
                <a:latin typeface="+mn-ea"/>
                <a:ea typeface="+mn-ea"/>
              </a:defRPr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正文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half" idx="2" hasCustomPrompt="1"/>
          </p:nvPr>
        </p:nvSpPr>
        <p:spPr>
          <a:xfrm>
            <a:off x="630079" y="1866371"/>
            <a:ext cx="2948940" cy="3243263"/>
          </a:xfrm>
        </p:spPr>
        <p:txBody>
          <a:bodyPr/>
          <a:lstStyle>
            <a:lvl1pPr marL="257175" indent="-257175">
              <a:buFont typeface="Arial" panose="020B0604020202020204" pitchFamily="34" charset="0"/>
              <a:buChar char="•"/>
              <a:defRPr sz="1800">
                <a:latin typeface="+mn-ea"/>
                <a:ea typeface="+mn-ea"/>
              </a:defRPr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正文</a:t>
            </a:r>
          </a:p>
          <a:p>
            <a:pPr lvl="0"/>
            <a:r>
              <a:rPr lang="zh-CN" altLang="en-US">
                <a:sym typeface="+mn-ea"/>
              </a:rPr>
              <a:t>单击此处编辑正文</a:t>
            </a:r>
            <a:endParaRPr lang="zh-CN" altLang="en-US"/>
          </a:p>
          <a:p>
            <a:pPr lvl="0"/>
            <a:r>
              <a:rPr lang="zh-CN" altLang="en-US">
                <a:sym typeface="+mn-ea"/>
              </a:rPr>
              <a:t>单击此处编辑正文</a:t>
            </a:r>
            <a:endParaRPr lang="zh-CN" altLang="en-US"/>
          </a:p>
          <a:p>
            <a:pPr lvl="0"/>
            <a:r>
              <a:rPr lang="zh-CN" altLang="en-US">
                <a:sym typeface="+mn-ea"/>
              </a:rPr>
              <a:t>单击此处编辑正文</a:t>
            </a:r>
          </a:p>
          <a:p>
            <a:pPr lvl="0"/>
            <a:r>
              <a:rPr lang="zh-CN" altLang="en-US">
                <a:sym typeface="+mn-ea"/>
              </a:rPr>
              <a:t>单击此处编辑正文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注释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+mn-ea"/>
              </a:defRPr>
            </a:lvl1pPr>
          </a:lstStyle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+mn-ea"/>
              </a:defRPr>
            </a:lvl1pPr>
          </a:lstStyle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 hasCustomPrompt="1"/>
          </p:nvPr>
        </p:nvSpPr>
        <p:spPr>
          <a:xfrm>
            <a:off x="502444" y="4670954"/>
            <a:ext cx="8139113" cy="465138"/>
          </a:xfrm>
        </p:spPr>
        <p:txBody>
          <a:bodyPr/>
          <a:lstStyle>
            <a:lvl1pPr>
              <a:defRPr b="0">
                <a:latin typeface="+mn-ea"/>
                <a:ea typeface="+mn-ea"/>
              </a:defRPr>
            </a:lvl1pPr>
          </a:lstStyle>
          <a:p>
            <a:r>
              <a:rPr lang="zh-CN" altLang="en-US"/>
              <a:t>单击此处编辑正文</a:t>
            </a:r>
          </a:p>
        </p:txBody>
      </p:sp>
      <p:sp>
        <p:nvSpPr>
          <p:cNvPr id="8" name="内容占位符 7"/>
          <p:cNvSpPr>
            <a:spLocks noGrp="1"/>
          </p:cNvSpPr>
          <p:nvPr>
            <p:ph idx="1" hasCustomPrompt="1"/>
          </p:nvPr>
        </p:nvSpPr>
        <p:spPr>
          <a:xfrm>
            <a:off x="502444" y="534458"/>
            <a:ext cx="8139113" cy="3796771"/>
          </a:xfrm>
        </p:spPr>
        <p:txBody>
          <a:bodyPr vert="horz" lIns="101600" tIns="0" rIns="82550" bIns="0" rtlCol="0">
            <a:no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8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1pPr>
            <a:lvl2pPr marL="342900" marR="0" lvl="1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None/>
              <a:tabLst>
                <a:tab pos="1609725" algn="l"/>
              </a:tabLst>
              <a:defRPr kumimoji="0" lang="zh-CN" altLang="en-US" sz="18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8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8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8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正文</a:t>
            </a: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单张大图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+mn-ea"/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+mn-ea"/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idx="1" hasCustomPrompt="1"/>
          </p:nvPr>
        </p:nvSpPr>
        <p:spPr>
          <a:xfrm>
            <a:off x="0" y="0"/>
            <a:ext cx="9147334" cy="5723467"/>
          </a:xfrm>
        </p:spPr>
        <p:txBody>
          <a:bodyPr vert="horz" lIns="101600" tIns="0" rIns="82550" bIns="0" rtlCol="0">
            <a:no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8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1pPr>
            <a:lvl2pPr marL="342900" marR="0" lvl="1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None/>
              <a:tabLst>
                <a:tab pos="1609725" algn="l"/>
              </a:tabLst>
              <a:defRPr kumimoji="0" lang="zh-CN" altLang="en-US" sz="18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8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8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8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正文</a:t>
            </a: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两联图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+mn-ea"/>
              </a:defRPr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+mn-ea"/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内容占位符 1"/>
          <p:cNvSpPr>
            <a:spLocks noGrp="1"/>
          </p:cNvSpPr>
          <p:nvPr>
            <p:ph sz="half" idx="2" hasCustomPrompt="1"/>
          </p:nvPr>
        </p:nvSpPr>
        <p:spPr>
          <a:xfrm>
            <a:off x="350996" y="470958"/>
            <a:ext cx="4050030" cy="4773083"/>
          </a:xfrm>
        </p:spPr>
        <p:txBody>
          <a:bodyPr vert="horz" lIns="101600" tIns="0" rIns="82550" bIns="0" rtlCol="0">
            <a:no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8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8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8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8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8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正文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half" idx="13" hasCustomPrompt="1"/>
          </p:nvPr>
        </p:nvSpPr>
        <p:spPr>
          <a:xfrm>
            <a:off x="4715828" y="470958"/>
            <a:ext cx="4050030" cy="4773083"/>
          </a:xfrm>
        </p:spPr>
        <p:txBody>
          <a:bodyPr vert="horz" lIns="101600" tIns="0" rIns="82550" bIns="0" rtlCol="0">
            <a:no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8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8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8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8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8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ea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</a:t>
            </a:r>
            <a:r>
              <a:rPr>
                <a:sym typeface="+mn-ea"/>
              </a:rPr>
              <a:t>正文</a:t>
            </a:r>
            <a:endParaRPr dirty="0">
              <a:sym typeface="+mn-ea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+mn-ea"/>
              </a:defRPr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+mn-ea"/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</p:nvPr>
        </p:nvSpPr>
        <p:spPr>
          <a:xfrm>
            <a:off x="502412" y="519659"/>
            <a:ext cx="8139178" cy="749306"/>
          </a:xfrm>
        </p:spPr>
        <p:txBody>
          <a:bodyPr vert="horz" lIns="101600" tIns="38100" rIns="25400" bIns="38100" rtlCol="0" anchor="ctr" anchorCtr="0">
            <a:noAutofit/>
          </a:bodyPr>
          <a:lstStyle>
            <a:lvl1pPr marL="0" marR="0" algn="ctr" defTabSz="914400" rtl="0" eaLnBrk="1" fontAlgn="auto" latinLnBrk="0" hangingPunct="1">
              <a:lnSpc>
                <a:spcPct val="100000"/>
              </a:lnSpc>
              <a:buNone/>
              <a:defRPr kumimoji="0" lang="zh-CN" altLang="en-US" sz="2400" b="0" i="0" u="none" strike="noStrike" kern="1200" cap="none" spc="600" normalizeH="0" baseline="0" noProof="1" dirty="0">
                <a:solidFill>
                  <a:schemeClr val="tx1"/>
                </a:solidFill>
                <a:effectLst/>
                <a:uFillTx/>
                <a:latin typeface="+mn-ea"/>
                <a:ea typeface="+mn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+mn-ea"/>
              </a:defRPr>
            </a:lvl1pPr>
          </a:lstStyle>
          <a:p>
            <a:endParaRPr lang="zh-CN" altLang="en-US" dirty="0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+mn-ea"/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13366" y="1413403"/>
            <a:ext cx="6858000" cy="672836"/>
          </a:xfrm>
          <a:prstGeom prst="rect">
            <a:avLst/>
          </a:prstGeom>
        </p:spPr>
        <p:txBody>
          <a:bodyPr anchor="b">
            <a:normAutofit/>
          </a:bodyPr>
          <a:lstStyle>
            <a:lvl1pPr algn="l">
              <a:defRPr sz="3600"/>
            </a:lvl1pPr>
          </a:lstStyle>
          <a:p>
            <a:r>
              <a:rPr lang="zh-CN" altLang="en-US" dirty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001698"/>
            <a:ext cx="6858000" cy="137980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pic>
        <p:nvPicPr>
          <p:cNvPr id="9" name="图片 8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80867" y="5246787"/>
            <a:ext cx="1144186" cy="312469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 userDrawn="1"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2502" b="36944"/>
          <a:stretch>
            <a:fillRect/>
          </a:stretch>
        </p:blipFill>
        <p:spPr>
          <a:xfrm rot="16200000">
            <a:off x="7489496" y="51129"/>
            <a:ext cx="1705634" cy="1603375"/>
          </a:xfrm>
          <a:prstGeom prst="rect">
            <a:avLst/>
          </a:prstGeom>
        </p:spPr>
      </p:pic>
      <p:pic>
        <p:nvPicPr>
          <p:cNvPr id="8" name="图形 7"/>
          <p:cNvPicPr>
            <a:picLocks noChangeAspect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324836" y="5191114"/>
            <a:ext cx="1688289" cy="287777"/>
          </a:xfrm>
          <a:prstGeom prst="rect">
            <a:avLst/>
          </a:prstGeom>
        </p:spPr>
      </p:pic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theme" Target="../theme/theme2.xml"/><Relationship Id="rId3" Type="http://schemas.openxmlformats.org/officeDocument/2006/relationships/slideLayout" Target="../slideLayouts/slideLayout11.xml"/><Relationship Id="rId7" Type="http://schemas.openxmlformats.org/officeDocument/2006/relationships/slideLayout" Target="../slideLayouts/slideLayout15.xml"/><Relationship Id="rId2" Type="http://schemas.openxmlformats.org/officeDocument/2006/relationships/slideLayout" Target="../slideLayouts/slideLayout10.xml"/><Relationship Id="rId1" Type="http://schemas.openxmlformats.org/officeDocument/2006/relationships/slideLayout" Target="../slideLayouts/slideLayout9.xml"/><Relationship Id="rId6" Type="http://schemas.openxmlformats.org/officeDocument/2006/relationships/slideLayout" Target="../slideLayouts/slideLayout14.xml"/><Relationship Id="rId5" Type="http://schemas.openxmlformats.org/officeDocument/2006/relationships/slideLayout" Target="../slideLayouts/slideLayout13.xml"/><Relationship Id="rId4" Type="http://schemas.openxmlformats.org/officeDocument/2006/relationships/slideLayout" Target="../slideLayouts/slideLayout1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59807" y="5291528"/>
            <a:ext cx="2025000" cy="26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  <a:latin typeface="+mn-ea"/>
              </a:defRPr>
            </a:lvl1pPr>
          </a:lstStyle>
          <a:p>
            <a:fld id="{760FBDFE-C587-4B4C-A407-44438C67B59E}" type="datetimeFigureOut">
              <a:rPr lang="zh-CN" altLang="en-US" smtClean="0"/>
              <a:t>2024/11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087000" y="5291528"/>
            <a:ext cx="2970000" cy="26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  <a:latin typeface="+mn-ea"/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457950" y="5291528"/>
            <a:ext cx="2025000" cy="26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  <a:latin typeface="+mn-ea"/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  <p:sp>
        <p:nvSpPr>
          <p:cNvPr id="7" name="KSO_TEMPLATE" hidden="1"/>
          <p:cNvSpPr/>
          <p:nvPr userDrawn="1"/>
        </p:nvSpPr>
        <p:spPr>
          <a:xfrm>
            <a:off x="0" y="0"/>
            <a:ext cx="0" cy="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350"/>
          </a:p>
        </p:txBody>
      </p:sp>
      <p:sp>
        <p:nvSpPr>
          <p:cNvPr id="8" name="标题 7"/>
          <p:cNvSpPr>
            <a:spLocks noGrp="1"/>
          </p:cNvSpPr>
          <p:nvPr>
            <p:ph type="title" hasCustomPrompt="1"/>
          </p:nvPr>
        </p:nvSpPr>
        <p:spPr>
          <a:xfrm>
            <a:off x="502412" y="484354"/>
            <a:ext cx="8139178" cy="540000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4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n-ea"/>
                <a:ea typeface="+mn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标题</a:t>
            </a:r>
          </a:p>
        </p:txBody>
      </p:sp>
      <p:sp>
        <p:nvSpPr>
          <p:cNvPr id="9" name="文本占位符 8"/>
          <p:cNvSpPr>
            <a:spLocks noGrp="1"/>
          </p:cNvSpPr>
          <p:nvPr>
            <p:ph type="body" idx="1" hasCustomPrompt="1"/>
          </p:nvPr>
        </p:nvSpPr>
        <p:spPr>
          <a:xfrm>
            <a:off x="502444" y="1256771"/>
            <a:ext cx="8139113" cy="3957638"/>
          </a:xfrm>
          <a:prstGeom prst="rect">
            <a:avLst/>
          </a:prstGeom>
        </p:spPr>
        <p:txBody>
          <a:bodyPr vert="horz" lIns="101600" tIns="0" rIns="82550" bIns="0" rtlCol="0">
            <a:normAutofit/>
          </a:bodyPr>
          <a:lstStyle>
            <a:lvl1pPr>
              <a:defRPr sz="18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</a:lstStyle>
          <a:p>
            <a:pPr lvl="0"/>
            <a:r>
              <a:rPr lang="zh-CN" altLang="en-US" dirty="0"/>
              <a:t>单击此处编辑正文</a:t>
            </a:r>
          </a:p>
          <a:p>
            <a:pPr lvl="0"/>
            <a:r>
              <a:rPr lang="zh-CN" altLang="en-US" dirty="0">
                <a:sym typeface="+mn-ea"/>
              </a:rPr>
              <a:t>单击此处编辑正文</a:t>
            </a:r>
            <a:endParaRPr lang="zh-CN" altLang="en-US" dirty="0"/>
          </a:p>
          <a:p>
            <a:pPr lvl="0"/>
            <a:r>
              <a:rPr lang="zh-CN" altLang="en-US" dirty="0">
                <a:sym typeface="+mn-ea"/>
              </a:rPr>
              <a:t>单击此处编辑正文</a:t>
            </a:r>
            <a:endParaRPr lang="zh-CN" altLang="en-US" dirty="0"/>
          </a:p>
          <a:p>
            <a:pPr lvl="0"/>
            <a:r>
              <a:rPr lang="zh-CN" altLang="en-US" dirty="0">
                <a:sym typeface="+mn-ea"/>
              </a:rPr>
              <a:t>单击此处编辑正文</a:t>
            </a:r>
            <a:endParaRPr lang="zh-CN" altLang="en-US" dirty="0"/>
          </a:p>
          <a:p>
            <a:pPr lvl="0"/>
            <a:r>
              <a:rPr lang="zh-CN" altLang="en-US" dirty="0">
                <a:sym typeface="+mn-ea"/>
              </a:rPr>
              <a:t>单击此处编辑正文</a:t>
            </a:r>
            <a:endParaRPr lang="zh-CN" alt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</p:sldLayoutIdLst>
  <p:txStyles>
    <p:titleStyle>
      <a:lvl1pPr algn="l" defTabSz="685800" rtl="0" eaLnBrk="1" fontAlgn="auto" latinLnBrk="0" hangingPunct="1">
        <a:lnSpc>
          <a:spcPct val="100000"/>
        </a:lnSpc>
        <a:spcBef>
          <a:spcPct val="0"/>
        </a:spcBef>
        <a:buNone/>
        <a:defRPr sz="2100" b="1" u="none" strike="noStrike" kern="1200" cap="none" spc="200" normalizeH="0">
          <a:solidFill>
            <a:schemeClr val="tx1"/>
          </a:solidFill>
          <a:uFillTx/>
          <a:latin typeface="+mn-ea"/>
          <a:ea typeface="+mn-ea"/>
          <a:cs typeface="+mj-cs"/>
        </a:defRPr>
      </a:lvl1pPr>
    </p:titleStyle>
    <p:bodyStyle>
      <a:lvl1pPr marL="1714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200" u="none" strike="noStrike" kern="1200" cap="none" spc="150" normalizeH="0" baseline="0">
          <a:solidFill>
            <a:schemeClr val="tx1"/>
          </a:solidFill>
          <a:uFillTx/>
          <a:latin typeface="+mn-ea"/>
          <a:ea typeface="+mn-ea"/>
          <a:cs typeface="+mn-cs"/>
        </a:defRPr>
      </a:lvl1pPr>
      <a:lvl2pPr marL="5143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tabLst>
          <a:tab pos="1207135" algn="l"/>
        </a:tabLst>
        <a:defRPr sz="1200" u="none" strike="noStrike" kern="1200" cap="none" spc="150" normalizeH="0" baseline="0">
          <a:solidFill>
            <a:schemeClr val="tx1"/>
          </a:solidFill>
          <a:uFillTx/>
          <a:latin typeface="+mn-ea"/>
          <a:ea typeface="+mn-ea"/>
          <a:cs typeface="+mn-cs"/>
        </a:defRPr>
      </a:lvl2pPr>
      <a:lvl3pPr marL="8572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200" u="none" strike="noStrike" kern="1200" cap="none" spc="150" normalizeH="0" baseline="0">
          <a:solidFill>
            <a:schemeClr val="tx1"/>
          </a:solidFill>
          <a:uFillTx/>
          <a:latin typeface="+mn-ea"/>
          <a:ea typeface="+mn-ea"/>
          <a:cs typeface="+mn-cs"/>
        </a:defRPr>
      </a:lvl3pPr>
      <a:lvl4pPr marL="12001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200" u="none" strike="noStrike" kern="1200" cap="none" spc="150" normalizeH="0" baseline="0">
          <a:solidFill>
            <a:schemeClr val="tx1"/>
          </a:solidFill>
          <a:uFillTx/>
          <a:latin typeface="+mn-ea"/>
          <a:ea typeface="+mn-ea"/>
          <a:cs typeface="+mn-cs"/>
        </a:defRPr>
      </a:lvl4pPr>
      <a:lvl5pPr marL="15430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200" u="none" strike="noStrike" kern="1200" cap="none" spc="150" normalizeH="0" baseline="0">
          <a:solidFill>
            <a:schemeClr val="tx1"/>
          </a:solidFill>
          <a:uFillTx/>
          <a:latin typeface="+mn-ea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  <p:sldLayoutId id="2147483659" r:id="rId2"/>
    <p:sldLayoutId id="2147483660" r:id="rId3"/>
    <p:sldLayoutId id="2147483661" r:id="rId4"/>
    <p:sldLayoutId id="2147483662" r:id="rId5"/>
    <p:sldLayoutId id="2147483663" r:id="rId6"/>
    <p:sldLayoutId id="2147483664" r:id="rId7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4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14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14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10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14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4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8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8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4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4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4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4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4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4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14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1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DD9005C-22EE-A581-F0F0-730C3C9161B0}"/>
              </a:ext>
            </a:extLst>
          </p:cNvPr>
          <p:cNvSpPr txBox="1"/>
          <p:nvPr/>
        </p:nvSpPr>
        <p:spPr>
          <a:xfrm>
            <a:off x="1960331" y="258238"/>
            <a:ext cx="4572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: 22 Alpaca used in this study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8AB8992B-C65A-F2E1-0244-E51878337B0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53460016"/>
              </p:ext>
            </p:extLst>
          </p:nvPr>
        </p:nvGraphicFramePr>
        <p:xfrm>
          <a:off x="1960331" y="787941"/>
          <a:ext cx="3917724" cy="4522906"/>
        </p:xfrm>
        <a:graphic>
          <a:graphicData uri="http://schemas.openxmlformats.org/drawingml/2006/table">
            <a:tbl>
              <a:tblPr/>
              <a:tblGrid>
                <a:gridCol w="758269">
                  <a:extLst>
                    <a:ext uri="{9D8B030D-6E8A-4147-A177-3AD203B41FA5}">
                      <a16:colId xmlns:a16="http://schemas.microsoft.com/office/drawing/2014/main" val="2194317213"/>
                    </a:ext>
                  </a:extLst>
                </a:gridCol>
                <a:gridCol w="1074215">
                  <a:extLst>
                    <a:ext uri="{9D8B030D-6E8A-4147-A177-3AD203B41FA5}">
                      <a16:colId xmlns:a16="http://schemas.microsoft.com/office/drawing/2014/main" val="267760490"/>
                    </a:ext>
                  </a:extLst>
                </a:gridCol>
                <a:gridCol w="1184795">
                  <a:extLst>
                    <a:ext uri="{9D8B030D-6E8A-4147-A177-3AD203B41FA5}">
                      <a16:colId xmlns:a16="http://schemas.microsoft.com/office/drawing/2014/main" val="1557530117"/>
                    </a:ext>
                  </a:extLst>
                </a:gridCol>
                <a:gridCol w="900445">
                  <a:extLst>
                    <a:ext uri="{9D8B030D-6E8A-4147-A177-3AD203B41FA5}">
                      <a16:colId xmlns:a16="http://schemas.microsoft.com/office/drawing/2014/main" val="3903034476"/>
                    </a:ext>
                  </a:extLst>
                </a:gridCol>
              </a:tblGrid>
              <a:tr h="32605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D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ge (month)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ender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ge group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9550200"/>
                  </a:ext>
                </a:extLst>
              </a:tr>
              <a:tr h="1664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055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5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-4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17524029"/>
                  </a:ext>
                </a:extLst>
              </a:tr>
              <a:tr h="1664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056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5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-4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40874209"/>
                  </a:ext>
                </a:extLst>
              </a:tr>
              <a:tr h="1664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057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5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-4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64553513"/>
                  </a:ext>
                </a:extLst>
              </a:tr>
              <a:tr h="1664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058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5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-4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5811341"/>
                  </a:ext>
                </a:extLst>
              </a:tr>
              <a:tr h="1664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059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5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-4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02330008"/>
                  </a:ext>
                </a:extLst>
              </a:tr>
              <a:tr h="1664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060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5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-4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18620892"/>
                  </a:ext>
                </a:extLst>
              </a:tr>
              <a:tr h="1664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062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5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-4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44493910"/>
                  </a:ext>
                </a:extLst>
              </a:tr>
              <a:tr h="1664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068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5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-4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05828159"/>
                  </a:ext>
                </a:extLst>
              </a:tr>
              <a:tr h="1664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070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5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-4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66019477"/>
                  </a:ext>
                </a:extLst>
              </a:tr>
              <a:tr h="1664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072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5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-4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251542"/>
                  </a:ext>
                </a:extLst>
              </a:tr>
              <a:tr h="1664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075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5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-4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25854776"/>
                  </a:ext>
                </a:extLst>
              </a:tr>
              <a:tr h="1664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077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5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-4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69073170"/>
                  </a:ext>
                </a:extLst>
              </a:tr>
              <a:tr h="1664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078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5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-4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59906655"/>
                  </a:ext>
                </a:extLst>
              </a:tr>
              <a:tr h="1664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079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5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-4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67926651"/>
                  </a:ext>
                </a:extLst>
              </a:tr>
              <a:tr h="1664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080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5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-4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44423558"/>
                  </a:ext>
                </a:extLst>
              </a:tr>
              <a:tr h="1664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081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5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-4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31105304"/>
                  </a:ext>
                </a:extLst>
              </a:tr>
              <a:tr h="1664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082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5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-4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87602919"/>
                  </a:ext>
                </a:extLst>
              </a:tr>
              <a:tr h="1664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601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3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-2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2008229"/>
                  </a:ext>
                </a:extLst>
              </a:tr>
              <a:tr h="1664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602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0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-2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4079169"/>
                  </a:ext>
                </a:extLst>
              </a:tr>
              <a:tr h="1664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603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-1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19903587"/>
                  </a:ext>
                </a:extLst>
              </a:tr>
              <a:tr h="1664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604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-1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36277908"/>
                  </a:ext>
                </a:extLst>
              </a:tr>
              <a:tr h="1664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605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-1</a:t>
                      </a:r>
                    </a:p>
                  </a:txBody>
                  <a:tcPr marL="7886" marR="7886" marT="788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0747839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929468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01C7818B-9FBF-6E2E-63F6-6F009AD4C851}"/>
              </a:ext>
            </a:extLst>
          </p:cNvPr>
          <p:cNvSpPr txBox="1"/>
          <p:nvPr/>
        </p:nvSpPr>
        <p:spPr>
          <a:xfrm>
            <a:off x="791181" y="4082539"/>
            <a:ext cx="718201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igure S3: UMAP graph of 520 VHHs from structure database labeled based on its source of species (</a:t>
            </a: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. UMAP graph of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6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VHHs used in detail structure analysis, labeled using assigned VHH types (</a:t>
            </a: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. 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nanoBERT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is used to generate sequence embeddings.</a:t>
            </a:r>
            <a:endParaRPr kumimoji="0" lang="en-US" altLang="zh-CN" sz="12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pic>
        <p:nvPicPr>
          <p:cNvPr id="3" name="Picture 2" descr="A screenshot of a graph&#10;&#10;Description automatically generated">
            <a:extLst>
              <a:ext uri="{FF2B5EF4-FFF2-40B4-BE49-F238E27FC236}">
                <a16:creationId xmlns:a16="http://schemas.microsoft.com/office/drawing/2014/main" id="{24F0A9AD-E434-2797-9DD7-A00A986B088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600" y="0"/>
            <a:ext cx="7973200" cy="39039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7342887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oup of diagrams with different colored shapes&#10;&#10;Description automatically generated">
            <a:extLst>
              <a:ext uri="{FF2B5EF4-FFF2-40B4-BE49-F238E27FC236}">
                <a16:creationId xmlns:a16="http://schemas.microsoft.com/office/drawing/2014/main" id="{26DD4849-31FE-0F32-1FF9-9DF85056E0C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752" y="529739"/>
            <a:ext cx="5948619" cy="439352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2E32D76-FA6B-9152-4A4E-96C44D2C8D80}"/>
              </a:ext>
            </a:extLst>
          </p:cNvPr>
          <p:cNvSpPr txBox="1"/>
          <p:nvPr/>
        </p:nvSpPr>
        <p:spPr>
          <a:xfrm>
            <a:off x="6484434" y="1306657"/>
            <a:ext cx="2748775" cy="156549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igure S4: 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equence feature differences among 4 types of VHHs in structure dataset.  Similar differences to results in Figure 2 were observed in the comparison of CDR3 length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, PI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, CDR charges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and hydropathy (D) among 4 types of VHHs.</a:t>
            </a:r>
            <a:endParaRPr lang="en-US" sz="12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708946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49AC70-9F79-4E55-872E-CB762FB3FC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68842" y="4120634"/>
            <a:ext cx="7744409" cy="793750"/>
          </a:xfrm>
        </p:spPr>
        <p:txBody>
          <a:bodyPr/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 Structure of F and Y.  These two amino acids are very similar,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ydroxylation of F becomes Y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 descr="A chemical formula and a chemical structure&#10;&#10;Description automatically generated with medium confidence">
            <a:extLst>
              <a:ext uri="{FF2B5EF4-FFF2-40B4-BE49-F238E27FC236}">
                <a16:creationId xmlns:a16="http://schemas.microsoft.com/office/drawing/2014/main" id="{628361AD-08C2-F8A3-19BF-061C5511083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5380" y="604384"/>
            <a:ext cx="6271260" cy="30283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5190076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8D9924-6BC0-33CC-FBC3-D88BF66399F4}"/>
              </a:ext>
            </a:extLst>
          </p:cNvPr>
          <p:cNvSpPr>
            <a:spLocks noGrp="1"/>
          </p:cNvSpPr>
          <p:nvPr>
            <p:ph type="title" idx="4294967295"/>
          </p:nvPr>
        </p:nvSpPr>
        <p:spPr>
          <a:xfrm>
            <a:off x="781368" y="4311650"/>
            <a:ext cx="7745412" cy="793750"/>
          </a:xfrm>
          <a:prstGeom prst="rect">
            <a:avLst/>
          </a:prstGeom>
        </p:spPr>
        <p:txBody>
          <a:bodyPr/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</a:t>
            </a:r>
            <a:b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omparison of epitope and paratope sizes based on the number of amino acids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_C2 VHHs showed slightly larger epitope and paratope size among 4 types of VHHs (A). VHHs using FR2 for binding showed significantly larger epitope and paratope sizes (B).</a:t>
            </a:r>
            <a:endParaRPr 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Picture 7" descr="A comparison of a bar graph&#10;&#10;Description automatically generated with medium confidence">
            <a:extLst>
              <a:ext uri="{FF2B5EF4-FFF2-40B4-BE49-F238E27FC236}">
                <a16:creationId xmlns:a16="http://schemas.microsoft.com/office/drawing/2014/main" id="{0B62805F-D444-AD63-26CA-1084CE43762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4240"/>
            <a:ext cx="9144000" cy="36150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322333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>
            <a:extLst>
              <a:ext uri="{FF2B5EF4-FFF2-40B4-BE49-F238E27FC236}">
                <a16:creationId xmlns:a16="http://schemas.microsoft.com/office/drawing/2014/main" id="{A5689BDF-4F81-68E1-59DA-3E0458754669}"/>
              </a:ext>
            </a:extLst>
          </p:cNvPr>
          <p:cNvSpPr>
            <a:spLocks noGrp="1"/>
          </p:cNvSpPr>
          <p:nvPr>
            <p:ph type="title" idx="4294967295"/>
          </p:nvPr>
        </p:nvSpPr>
        <p:spPr>
          <a:xfrm>
            <a:off x="935355" y="4921250"/>
            <a:ext cx="7743825" cy="793750"/>
          </a:xfrm>
          <a:prstGeom prst="rect">
            <a:avLst/>
          </a:prstGeom>
        </p:spPr>
        <p:txBody>
          <a:bodyPr/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</a:t>
            </a:r>
            <a:b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t positive correlation (P&lt; 0.0001) was observed between CDR3 length and number of contact residues in CDR3</a:t>
            </a:r>
          </a:p>
        </p:txBody>
      </p:sp>
      <p:pic>
        <p:nvPicPr>
          <p:cNvPr id="7" name="Picture 6" descr="A graph of a number of dots&#10;&#10;Description automatically generated with medium confidence">
            <a:extLst>
              <a:ext uri="{FF2B5EF4-FFF2-40B4-BE49-F238E27FC236}">
                <a16:creationId xmlns:a16="http://schemas.microsoft.com/office/drawing/2014/main" id="{2ABE5F3B-EDFE-7E00-806B-E5BFB2C7AAD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9526" y="429764"/>
            <a:ext cx="5218187" cy="40325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815759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7F1DC89D-8B17-F3BF-A86B-62EEEE57CDFE}"/>
              </a:ext>
            </a:extLst>
          </p:cNvPr>
          <p:cNvSpPr txBox="1"/>
          <p:nvPr/>
        </p:nvSpPr>
        <p:spPr>
          <a:xfrm>
            <a:off x="468630" y="4941693"/>
            <a:ext cx="820674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8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ces in number of contact residues in CDR1/2/3 and FR2 regions (A) and contact residue distribution (B) between VHHs using FR2 in binding vs not. </a:t>
            </a: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The Y-axis (B) represents the percentage of VHHs involved in binding at a specified position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pic>
        <p:nvPicPr>
          <p:cNvPr id="2" name="Picture 1" descr="A graph of a graph&#10;&#10;Description automatically generated with medium confidence">
            <a:extLst>
              <a:ext uri="{FF2B5EF4-FFF2-40B4-BE49-F238E27FC236}">
                <a16:creationId xmlns:a16="http://schemas.microsoft.com/office/drawing/2014/main" id="{F0BBA086-AFD9-D5BE-E749-4FC5F0A65BD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5354" y="22860"/>
            <a:ext cx="7202805" cy="48852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5817577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96044D8-8998-28D3-7B22-DFD7EF292A79}"/>
              </a:ext>
            </a:extLst>
          </p:cNvPr>
          <p:cNvSpPr txBox="1"/>
          <p:nvPr/>
        </p:nvSpPr>
        <p:spPr>
          <a:xfrm>
            <a:off x="350448" y="4934188"/>
            <a:ext cx="854789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9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ample structures of Y_C2 VHHs display large concave (A, 7YAG), flat (B, 7KJI), convex (C, 7RNN), and loop (D, 6RTY) paratope shapes.  Example structure of F_C2 displays convex paratope (E, 7B2Q). VHHs are red colored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70CF87C6-2608-5293-BE4D-CF8703468B8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0031" y="287298"/>
            <a:ext cx="1274763" cy="197808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94ED22CD-7D9B-29C5-E91A-F31987C85A2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08777" y="376952"/>
            <a:ext cx="1840274" cy="1895311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A8BFA1CE-78C2-9C65-4E38-8B9F92810F8B}"/>
              </a:ext>
            </a:extLst>
          </p:cNvPr>
          <p:cNvSpPr txBox="1"/>
          <p:nvPr/>
        </p:nvSpPr>
        <p:spPr>
          <a:xfrm>
            <a:off x="2378867" y="206496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B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14B311CA-EA61-01FE-1D40-152C4B0FD00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07501" y="142398"/>
            <a:ext cx="1866216" cy="2364418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4BE17073-EA44-93C6-05F4-ED63CD9EE183}"/>
              </a:ext>
            </a:extLst>
          </p:cNvPr>
          <p:cNvSpPr txBox="1"/>
          <p:nvPr/>
        </p:nvSpPr>
        <p:spPr>
          <a:xfrm>
            <a:off x="4659067" y="206496"/>
            <a:ext cx="3385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C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BFF822D4-E3F3-FD1D-F9B1-A4770312264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83088" y="2354912"/>
            <a:ext cx="1765056" cy="2539432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96C49C4C-7AF3-2E52-6321-5CD1EB6B8A9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235015" y="2705732"/>
            <a:ext cx="2778757" cy="2020914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241EF958-EA64-E44C-5318-B0414503FC7E}"/>
              </a:ext>
            </a:extLst>
          </p:cNvPr>
          <p:cNvSpPr txBox="1"/>
          <p:nvPr/>
        </p:nvSpPr>
        <p:spPr>
          <a:xfrm>
            <a:off x="3039056" y="2540187"/>
            <a:ext cx="3385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4EC688D-8F84-5979-B2C0-15D0DE4E8460}"/>
              </a:ext>
            </a:extLst>
          </p:cNvPr>
          <p:cNvSpPr txBox="1"/>
          <p:nvPr/>
        </p:nvSpPr>
        <p:spPr>
          <a:xfrm>
            <a:off x="648959" y="2540187"/>
            <a:ext cx="3385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D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75987F9-EDCF-DBF8-AE53-329F06CEA815}"/>
              </a:ext>
            </a:extLst>
          </p:cNvPr>
          <p:cNvSpPr txBox="1"/>
          <p:nvPr/>
        </p:nvSpPr>
        <p:spPr>
          <a:xfrm>
            <a:off x="648959" y="206496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7194161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3">
            <a:extLst>
              <a:ext uri="{FF2B5EF4-FFF2-40B4-BE49-F238E27FC236}">
                <a16:creationId xmlns:a16="http://schemas.microsoft.com/office/drawing/2014/main" id="{C166BE22-A08C-5D1B-6602-FBFC329C158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23886660"/>
              </p:ext>
            </p:extLst>
          </p:nvPr>
        </p:nvGraphicFramePr>
        <p:xfrm>
          <a:off x="766474" y="1307800"/>
          <a:ext cx="7341044" cy="1345533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1738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9164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732020">
                  <a:extLst>
                    <a:ext uri="{9D8B030D-6E8A-4147-A177-3AD203B41FA5}">
                      <a16:colId xmlns:a16="http://schemas.microsoft.com/office/drawing/2014/main" val="3638202546"/>
                    </a:ext>
                  </a:extLst>
                </a:gridCol>
              </a:tblGrid>
              <a:tr h="293018"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ype</a:t>
                      </a:r>
                      <a:endParaRPr lang="zh-CN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me</a:t>
                      </a:r>
                      <a:endParaRPr lang="zh-CN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es</a:t>
                      </a:r>
                      <a:endParaRPr lang="zh-CN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4743">
                <a:tc rowSpan="3"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ade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ME207-LPVH1 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350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cagtggctgcaggtgtccactcg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4743">
                <a:tc vMerge="1"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endParaRPr/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ME207-LPVH14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350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caggtccccaaggtgtcctgtcc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74743">
                <a:tc vMerge="1"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endParaRPr dirty="0"/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ME207-LPVH13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350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caggtccccaaggtgtcctgtcc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4743">
                <a:tc rowSpan="2"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Hinge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sz="135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ME207-Hig2b 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350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tttttgttcctggcctcccgggccactagtttgtggttttggtgtcttggg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74743">
                <a:tc vMerge="1"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sz="135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ME207-Hig2c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350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tttttgttcctggcctcccgggccactagtggggtcttcgctgtggtgcgc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E83F8F44-C06C-12ED-03F8-4D7E3CD5F4EF}"/>
              </a:ext>
            </a:extLst>
          </p:cNvPr>
          <p:cNvSpPr txBox="1"/>
          <p:nvPr/>
        </p:nvSpPr>
        <p:spPr>
          <a:xfrm>
            <a:off x="1638624" y="489299"/>
            <a:ext cx="586675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/>
              <a:t>Table S2: Primer sequences for building NGS libraries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6605467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idx="4294967295"/>
          </p:nvPr>
        </p:nvSpPr>
        <p:spPr>
          <a:xfrm>
            <a:off x="1203570" y="194896"/>
            <a:ext cx="6599238" cy="415925"/>
          </a:xfrm>
          <a:prstGeom prst="rect">
            <a:avLst/>
          </a:prstGeom>
        </p:spPr>
        <p:txBody>
          <a:bodyPr>
            <a:norm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3: FR2 sequences in 17 VHH germlines of Alpac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26A1E7B1-C77C-4156-3BAC-F593F426F97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25606662"/>
              </p:ext>
            </p:extLst>
          </p:nvPr>
        </p:nvGraphicFramePr>
        <p:xfrm>
          <a:off x="1280926" y="610821"/>
          <a:ext cx="4159963" cy="3627440"/>
        </p:xfrm>
        <a:graphic>
          <a:graphicData uri="http://schemas.openxmlformats.org/drawingml/2006/table">
            <a:tbl>
              <a:tblPr/>
              <a:tblGrid>
                <a:gridCol w="2065896">
                  <a:extLst>
                    <a:ext uri="{9D8B030D-6E8A-4147-A177-3AD203B41FA5}">
                      <a16:colId xmlns:a16="http://schemas.microsoft.com/office/drawing/2014/main" val="1871324083"/>
                    </a:ext>
                  </a:extLst>
                </a:gridCol>
                <a:gridCol w="2094067">
                  <a:extLst>
                    <a:ext uri="{9D8B030D-6E8A-4147-A177-3AD203B41FA5}">
                      <a16:colId xmlns:a16="http://schemas.microsoft.com/office/drawing/2014/main" val="2554007934"/>
                    </a:ext>
                  </a:extLst>
                </a:gridCol>
              </a:tblGrid>
              <a:tr h="19734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me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2 Sequence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94524680"/>
                  </a:ext>
                </a:extLst>
              </a:tr>
              <a:tr h="19734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773729|IGHV3-3*01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W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QAPGK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A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86953443"/>
                  </a:ext>
                </a:extLst>
              </a:tr>
              <a:tr h="19734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773548|IGHV3S53*01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W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QAPGK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R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A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26307831"/>
                  </a:ext>
                </a:extLst>
              </a:tr>
              <a:tr h="19734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939756|IGHV3S54*01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W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QAPGK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R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A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748015"/>
                  </a:ext>
                </a:extLst>
              </a:tr>
              <a:tr h="19734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939763|IGHV3S55*01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W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QAPGK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A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24214343"/>
                  </a:ext>
                </a:extLst>
              </a:tr>
              <a:tr h="19734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939764|IGHV3S56*01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W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QAPGK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A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81676728"/>
                  </a:ext>
                </a:extLst>
              </a:tr>
              <a:tr h="19734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939765|IGHV3S57*01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W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QAPGK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A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82458188"/>
                  </a:ext>
                </a:extLst>
              </a:tr>
              <a:tr h="19734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939752|IGHV3S58*01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W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QAPGK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A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1533535"/>
                  </a:ext>
                </a:extLst>
              </a:tr>
              <a:tr h="19734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939753|IGHV3S59*01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W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QAPGK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A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44750802"/>
                  </a:ext>
                </a:extLst>
              </a:tr>
              <a:tr h="20674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939754|IGHV3S60*01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W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QAPGK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S</a:t>
                      </a:r>
                      <a:r>
                        <a:rPr lang="en-US" sz="1200" b="0" i="0" u="none" strike="noStrike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46890506"/>
                  </a:ext>
                </a:extLst>
              </a:tr>
              <a:tr h="20674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939757|IGHV3S61*01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W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QAPGK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S</a:t>
                      </a:r>
                      <a:r>
                        <a:rPr lang="en-US" sz="1200" b="0" i="0" u="none" strike="noStrike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14145714"/>
                  </a:ext>
                </a:extLst>
              </a:tr>
              <a:tr h="20674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939758|IGHV3S62*01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W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QAPGK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S</a:t>
                      </a:r>
                      <a:r>
                        <a:rPr lang="en-US" sz="1200" b="0" i="0" u="none" strike="noStrike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97726263"/>
                  </a:ext>
                </a:extLst>
              </a:tr>
              <a:tr h="20674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939759|IGHV3S63*01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W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QAPGK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S</a:t>
                      </a:r>
                      <a:r>
                        <a:rPr lang="en-US" sz="1200" b="0" i="0" u="none" strike="noStrike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73655195"/>
                  </a:ext>
                </a:extLst>
              </a:tr>
              <a:tr h="20674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939760|IGHV3S64*01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SW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QAPGK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S</a:t>
                      </a:r>
                      <a:r>
                        <a:rPr lang="en-US" sz="1200" b="0" i="0" u="none" strike="noStrike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72622806"/>
                  </a:ext>
                </a:extLst>
              </a:tr>
              <a:tr h="20674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939761|IGHV3S65*01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W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QAPGK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S</a:t>
                      </a:r>
                      <a:r>
                        <a:rPr lang="en-US" sz="1200" b="0" i="0" u="none" strike="noStrike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75691128"/>
                  </a:ext>
                </a:extLst>
              </a:tr>
              <a:tr h="20674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939762|IGHV3S66*01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W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QAPGK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S</a:t>
                      </a:r>
                      <a:r>
                        <a:rPr lang="en-US" sz="1200" b="0" i="0" u="none" strike="noStrike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31302202"/>
                  </a:ext>
                </a:extLst>
              </a:tr>
              <a:tr h="19734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939766|IGHV3S67*01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SW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QAPGK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</a:t>
                      </a:r>
                      <a:r>
                        <a:rPr lang="en-US" sz="12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A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95903976"/>
                  </a:ext>
                </a:extLst>
              </a:tr>
              <a:tr h="20674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939755|IGHV3S68*01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RW</a:t>
                      </a:r>
                      <a:r>
                        <a:rPr lang="en-US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QAPGK</a:t>
                      </a:r>
                      <a:r>
                        <a:rPr lang="en-US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</a:t>
                      </a:r>
                      <a:r>
                        <a:rPr lang="en-US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S</a:t>
                      </a:r>
                      <a:r>
                        <a:rPr lang="en-US" sz="1200" b="0" i="0" u="none" strike="noStrike" dirty="0">
                          <a:solidFill>
                            <a:srgbClr val="C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3177736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C0BFDDAB-F8DD-CCE9-46F6-5D6EF1B30F5E}"/>
              </a:ext>
            </a:extLst>
          </p:cNvPr>
          <p:cNvSpPr txBox="1"/>
          <p:nvPr/>
        </p:nvSpPr>
        <p:spPr>
          <a:xfrm>
            <a:off x="1145421" y="4580959"/>
            <a:ext cx="762519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Red colored residues are 4 VHH hallmark residues. Germlines with C (pink colored) at the end of FR2 are germlines for F_C4 type VHHs</a:t>
            </a:r>
          </a:p>
        </p:txBody>
      </p:sp>
    </p:spTree>
    <p:extLst>
      <p:ext uri="{BB962C8B-B14F-4D97-AF65-F5344CB8AC3E}">
        <p14:creationId xmlns:p14="http://schemas.microsoft.com/office/powerpoint/2010/main" val="13260103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0421C5-85EA-7189-0768-8EA1E75AA6DB}"/>
              </a:ext>
            </a:extLst>
          </p:cNvPr>
          <p:cNvSpPr>
            <a:spLocks noGrp="1"/>
          </p:cNvSpPr>
          <p:nvPr>
            <p:ph type="title" idx="4294967295"/>
          </p:nvPr>
        </p:nvSpPr>
        <p:spPr>
          <a:xfrm>
            <a:off x="1379220" y="557848"/>
            <a:ext cx="7886700" cy="758825"/>
          </a:xfrm>
          <a:prstGeom prst="rect">
            <a:avLst/>
          </a:prstGeom>
        </p:spPr>
        <p:txBody>
          <a:bodyPr/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4: Top 5 germlines for classical and non-classical VHHs and corresponding types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3A6D14D4-B9BB-7EE0-C365-BF01AB269BB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73584645"/>
              </p:ext>
            </p:extLst>
          </p:nvPr>
        </p:nvGraphicFramePr>
        <p:xfrm>
          <a:off x="1358678" y="1846226"/>
          <a:ext cx="6426643" cy="160877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3854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4873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28359">
                  <a:extLst>
                    <a:ext uri="{9D8B030D-6E8A-4147-A177-3AD203B41FA5}">
                      <a16:colId xmlns:a16="http://schemas.microsoft.com/office/drawing/2014/main" val="3638202546"/>
                    </a:ext>
                  </a:extLst>
                </a:gridCol>
                <a:gridCol w="103854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5483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017622">
                  <a:extLst>
                    <a:ext uri="{9D8B030D-6E8A-4147-A177-3AD203B41FA5}">
                      <a16:colId xmlns:a16="http://schemas.microsoft.com/office/drawing/2014/main" val="3226035917"/>
                    </a:ext>
                  </a:extLst>
                </a:gridCol>
              </a:tblGrid>
              <a:tr h="293845">
                <a:tc gridSpan="3"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assical VHHs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zh-CN" altLang="en-US" sz="1400" dirty="0"/>
                    </a:p>
                  </a:txBody>
                  <a:tcPr>
                    <a:lnL w="12700" cap="flat" cmpd="sng" algn="ctr">
                      <a:solidFill>
                        <a:srgbClr val="203B7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solidFill>
                        <a:srgbClr val="203B75"/>
                      </a:solidFill>
                    </a:lnR>
                    <a:lnT w="12700" cmpd="sng">
                      <a:solidFill>
                        <a:srgbClr val="203B75"/>
                      </a:solidFill>
                    </a:lnT>
                    <a:lnB w="12700" cap="flat" cmpd="sng" algn="ctr">
                      <a:solidFill>
                        <a:srgbClr val="203B7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3"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-classical VHHs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zh-CN" altLang="en-US" sz="1400" dirty="0"/>
                    </a:p>
                  </a:txBody>
                  <a:tcPr>
                    <a:lnL w="12700" cap="flat" cmpd="sng" algn="ctr">
                      <a:solidFill>
                        <a:srgbClr val="203B7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solidFill>
                        <a:srgbClr val="203B75"/>
                      </a:solidFill>
                    </a:lnR>
                    <a:lnT w="12700" cmpd="sng">
                      <a:solidFill>
                        <a:srgbClr val="203B75"/>
                      </a:solidFill>
                    </a:lnT>
                    <a:lnB w="12700" cap="flat" cmpd="sng" algn="ctr">
                      <a:solidFill>
                        <a:srgbClr val="203B7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93018"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rmline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rcentage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ype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rmline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rcentage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ype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4743"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HV3S53*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zh-CN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7%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_C2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HV4S5*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zh-CN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5%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_V4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4743"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HV3-3*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zh-CN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8%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_C2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HV4S1*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zh-CN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3%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_V4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74743"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HV3S65*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zh-CN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7%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_C4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HV3S39*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zh-CN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9%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_V3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4743"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HV3S61*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zh-CN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4%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_C4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HV3S42*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zh-CN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7%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_V3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74743"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HV3S66*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zh-CN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6%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_C4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HV3S1*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zh-CN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8%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_V3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447735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0421C5-85EA-7189-0768-8EA1E75AA6DB}"/>
              </a:ext>
            </a:extLst>
          </p:cNvPr>
          <p:cNvSpPr>
            <a:spLocks noGrp="1"/>
          </p:cNvSpPr>
          <p:nvPr>
            <p:ph type="title" idx="4294967295"/>
          </p:nvPr>
        </p:nvSpPr>
        <p:spPr>
          <a:xfrm>
            <a:off x="323406" y="590111"/>
            <a:ext cx="8898416" cy="562616"/>
          </a:xfrm>
          <a:prstGeom prst="rect">
            <a:avLst/>
          </a:prstGeom>
        </p:spPr>
        <p:txBody>
          <a:bodyPr/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5: Charge and hydropathy properties for top 5 germlines used in classical and non-classical VHHs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3A6D14D4-B9BB-7EE0-C365-BF01AB269BB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92971557"/>
              </p:ext>
            </p:extLst>
          </p:nvPr>
        </p:nvGraphicFramePr>
        <p:xfrm>
          <a:off x="159463" y="1798006"/>
          <a:ext cx="8580676" cy="24953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46363">
                  <a:extLst>
                    <a:ext uri="{9D8B030D-6E8A-4147-A177-3AD203B41FA5}">
                      <a16:colId xmlns:a16="http://schemas.microsoft.com/office/drawing/2014/main" val="4101781305"/>
                    </a:ext>
                  </a:extLst>
                </a:gridCol>
                <a:gridCol w="94108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3834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21575">
                  <a:extLst>
                    <a:ext uri="{9D8B030D-6E8A-4147-A177-3AD203B41FA5}">
                      <a16:colId xmlns:a16="http://schemas.microsoft.com/office/drawing/2014/main" val="3638202546"/>
                    </a:ext>
                  </a:extLst>
                </a:gridCol>
                <a:gridCol w="99920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7989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118514">
                  <a:extLst>
                    <a:ext uri="{9D8B030D-6E8A-4147-A177-3AD203B41FA5}">
                      <a16:colId xmlns:a16="http://schemas.microsoft.com/office/drawing/2014/main" val="3226035917"/>
                    </a:ext>
                  </a:extLst>
                </a:gridCol>
                <a:gridCol w="1014119">
                  <a:extLst>
                    <a:ext uri="{9D8B030D-6E8A-4147-A177-3AD203B41FA5}">
                      <a16:colId xmlns:a16="http://schemas.microsoft.com/office/drawing/2014/main" val="718840038"/>
                    </a:ext>
                  </a:extLst>
                </a:gridCol>
                <a:gridCol w="1021577">
                  <a:extLst>
                    <a:ext uri="{9D8B030D-6E8A-4147-A177-3AD203B41FA5}">
                      <a16:colId xmlns:a16="http://schemas.microsoft.com/office/drawing/2014/main" val="2628625172"/>
                    </a:ext>
                  </a:extLst>
                </a:gridCol>
              </a:tblGrid>
              <a:tr h="362263">
                <a:tc>
                  <a:txBody>
                    <a:bodyPr/>
                    <a:lstStyle/>
                    <a:p>
                      <a:pPr algn="ctr"/>
                      <a:endParaRPr lang="zh-CN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rmline</a:t>
                      </a:r>
                      <a:endParaRPr lang="zh-CN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ype</a:t>
                      </a:r>
                      <a:endParaRPr lang="zh-CN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ll length charge</a:t>
                      </a:r>
                      <a:endParaRPr lang="zh-CN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R1 charge</a:t>
                      </a:r>
                      <a:endParaRPr lang="zh-CN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R2 charge</a:t>
                      </a:r>
                      <a:endParaRPr lang="zh-CN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ll length hydropathy</a:t>
                      </a:r>
                      <a:endParaRPr lang="zh-CN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R1 hydropathy</a:t>
                      </a:r>
                      <a:endParaRPr lang="zh-CN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R2 hydropathy</a:t>
                      </a:r>
                      <a:endParaRPr lang="zh-CN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11420">
                <a:tc rowSpan="5"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assical VHHs</a:t>
                      </a:r>
                      <a:endParaRPr lang="zh-CN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HV3S53*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_C2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4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12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2452">
                <a:tc vMerge="1">
                  <a:txBody>
                    <a:bodyPr/>
                    <a:lstStyle/>
                    <a:p>
                      <a:pPr algn="ctr" rtl="0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HV3-3*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_C2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3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487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37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11420">
                <a:tc vMerge="1">
                  <a:txBody>
                    <a:bodyPr/>
                    <a:lstStyle/>
                    <a:p>
                      <a:pPr algn="ctr" rtl="0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HV3S65*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_C4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30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2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11420">
                <a:tc vMerge="1">
                  <a:txBody>
                    <a:bodyPr/>
                    <a:lstStyle/>
                    <a:p>
                      <a:pPr algn="ctr" rtl="0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HV3S61*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_C4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412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11420">
                <a:tc vMerge="1">
                  <a:txBody>
                    <a:bodyPr/>
                    <a:lstStyle/>
                    <a:p>
                      <a:pPr algn="ctr" rtl="0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HV3S66*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_C4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412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52452">
                <a:tc rowSpan="5"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-classical VHHs</a:t>
                      </a:r>
                      <a:endParaRPr lang="zh-CN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HV4S5*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_V4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38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3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571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79031592"/>
                  </a:ext>
                </a:extLst>
              </a:tr>
              <a:tr h="152452">
                <a:tc vMerge="1">
                  <a:txBody>
                    <a:bodyPr/>
                    <a:lstStyle/>
                    <a:p>
                      <a:pPr algn="ctr" rtl="0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HV4S1*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_V4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37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571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73907080"/>
                  </a:ext>
                </a:extLst>
              </a:tr>
              <a:tr h="211420">
                <a:tc vMerge="1">
                  <a:txBody>
                    <a:bodyPr/>
                    <a:lstStyle/>
                    <a:p>
                      <a:pPr algn="ctr" rtl="0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HV3S39*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_V3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1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2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312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92833270"/>
                  </a:ext>
                </a:extLst>
              </a:tr>
              <a:tr h="211420">
                <a:tc vMerge="1">
                  <a:txBody>
                    <a:bodyPr/>
                    <a:lstStyle/>
                    <a:p>
                      <a:pPr algn="ctr" rtl="0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HV3S42*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_V3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15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2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312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82696068"/>
                  </a:ext>
                </a:extLst>
              </a:tr>
              <a:tr h="152452">
                <a:tc vMerge="1">
                  <a:txBody>
                    <a:bodyPr/>
                    <a:lstStyle/>
                    <a:p>
                      <a:pPr algn="ctr" rtl="0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rtl="0" fontAlgn="ctr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HV3S1*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_V3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3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7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3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5816246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102006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0421C5-85EA-7189-0768-8EA1E75AA6DB}"/>
              </a:ext>
            </a:extLst>
          </p:cNvPr>
          <p:cNvSpPr>
            <a:spLocks noGrp="1"/>
          </p:cNvSpPr>
          <p:nvPr>
            <p:ph type="title" idx="4294967295"/>
          </p:nvPr>
        </p:nvSpPr>
        <p:spPr>
          <a:xfrm>
            <a:off x="802331" y="448736"/>
            <a:ext cx="8229802" cy="387843"/>
          </a:xfrm>
          <a:prstGeom prst="rect">
            <a:avLst/>
          </a:prstGeom>
        </p:spPr>
        <p:txBody>
          <a:bodyPr/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6: Sequences for two hinges used in Alpaca VHHs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3A6D14D4-B9BB-7EE0-C365-BF01AB269BB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78619913"/>
              </p:ext>
            </p:extLst>
          </p:nvPr>
        </p:nvGraphicFramePr>
        <p:xfrm>
          <a:off x="420757" y="1596995"/>
          <a:ext cx="8302486" cy="119874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82851">
                  <a:extLst>
                    <a:ext uri="{9D8B030D-6E8A-4147-A177-3AD203B41FA5}">
                      <a16:colId xmlns:a16="http://schemas.microsoft.com/office/drawing/2014/main" val="1913160505"/>
                    </a:ext>
                  </a:extLst>
                </a:gridCol>
                <a:gridCol w="260286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7140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245371">
                  <a:extLst>
                    <a:ext uri="{9D8B030D-6E8A-4147-A177-3AD203B41FA5}">
                      <a16:colId xmlns:a16="http://schemas.microsoft.com/office/drawing/2014/main" val="3638202546"/>
                    </a:ext>
                  </a:extLst>
                </a:gridCol>
              </a:tblGrid>
              <a:tr h="452937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ype</a:t>
                      </a:r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 Name</a:t>
                      </a:r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</a:t>
                      </a:r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NA</a:t>
                      </a:r>
                      <a:endParaRPr lang="zh-CN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967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B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marL="0" indent="0">
                        <a:buNone/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773729|IGHG2B*01|Vicugna </a:t>
                      </a:r>
                      <a:r>
                        <a:rPr lang="en-US" sz="1200" b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cos|F|H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KTPKPQPQPQPQPQPNPTTESKCPKCP</a:t>
                      </a:r>
                      <a:endParaRPr lang="en-US" altLang="zh-CN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acccaagacaccaaaaccacaaccacaaccacaaccacaaccccaacccaatcctacaacagaatccaagtgtcccaaatgtcc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79031592"/>
                  </a:ext>
                </a:extLst>
              </a:tr>
              <a:tr h="25967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C</a:t>
                      </a: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sz="135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marL="0" indent="0">
                        <a:buNone/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773729|IGHG2C*01|Vicugna </a:t>
                      </a:r>
                      <a:r>
                        <a:rPr lang="en-US" sz="1200" b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cos|F|H</a:t>
                      </a:r>
                      <a:endParaRPr 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HHSEDPSSKCPKCP</a:t>
                      </a:r>
                      <a:endParaRPr lang="en-US" altLang="zh-CN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gcaccacagcgaagaccccagctccaagtgtcccaaatgccca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7390708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3264129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C0D6E5-5F71-C6E8-AC28-66467FEB3B0A}"/>
              </a:ext>
            </a:extLst>
          </p:cNvPr>
          <p:cNvSpPr>
            <a:spLocks noGrp="1"/>
          </p:cNvSpPr>
          <p:nvPr>
            <p:ph type="title" idx="4294967295"/>
          </p:nvPr>
        </p:nvSpPr>
        <p:spPr>
          <a:xfrm>
            <a:off x="968442" y="488699"/>
            <a:ext cx="9003323" cy="1005131"/>
          </a:xfrm>
          <a:prstGeom prst="rect">
            <a:avLst/>
          </a:prstGeom>
        </p:spPr>
        <p:txBody>
          <a:bodyPr/>
          <a:lstStyle/>
          <a:p>
            <a:r>
              <a:rPr lang="en-US" altLang="zh-CN" sz="1200" dirty="0"/>
              <a:t>Table S7: Numbers of 4 types of VHHs in structure dataset</a:t>
            </a:r>
            <a:endParaRPr lang="en-US" sz="1200" dirty="0"/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276A0760-9C51-56F5-75A8-1D35163BBB5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58440672"/>
              </p:ext>
            </p:extLst>
          </p:nvPr>
        </p:nvGraphicFramePr>
        <p:xfrm>
          <a:off x="2276930" y="1587194"/>
          <a:ext cx="3293104" cy="16687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90323">
                  <a:extLst>
                    <a:ext uri="{9D8B030D-6E8A-4147-A177-3AD203B41FA5}">
                      <a16:colId xmlns:a16="http://schemas.microsoft.com/office/drawing/2014/main" val="2815238344"/>
                    </a:ext>
                  </a:extLst>
                </a:gridCol>
                <a:gridCol w="2002781">
                  <a:extLst>
                    <a:ext uri="{9D8B030D-6E8A-4147-A177-3AD203B41FA5}">
                      <a16:colId xmlns:a16="http://schemas.microsoft.com/office/drawing/2014/main" val="2235761758"/>
                    </a:ext>
                  </a:extLst>
                </a:gridCol>
              </a:tblGrid>
              <a:tr h="333756">
                <a:tc>
                  <a:txBody>
                    <a:bodyPr/>
                    <a:lstStyle/>
                    <a:p>
                      <a:endParaRPr lang="en-US"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296" marR="82296" marT="41148" marB="41148"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sequences</a:t>
                      </a:r>
                    </a:p>
                  </a:txBody>
                  <a:tcPr marL="82296" marR="82296" marT="41148" marB="41148"/>
                </a:tc>
                <a:extLst>
                  <a:ext uri="{0D108BD9-81ED-4DB2-BD59-A6C34878D82A}">
                    <a16:rowId xmlns:a16="http://schemas.microsoft.com/office/drawing/2014/main" val="3462650620"/>
                  </a:ext>
                </a:extLst>
              </a:tr>
              <a:tr h="333756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_C2</a:t>
                      </a:r>
                    </a:p>
                  </a:txBody>
                  <a:tcPr marL="82296" marR="82296" marT="41148" marB="41148"/>
                </a:tc>
                <a:tc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6</a:t>
                      </a:r>
                    </a:p>
                  </a:txBody>
                  <a:tcPr marL="82296" marR="82296" marT="41148" marB="41148"/>
                </a:tc>
                <a:extLst>
                  <a:ext uri="{0D108BD9-81ED-4DB2-BD59-A6C34878D82A}">
                    <a16:rowId xmlns:a16="http://schemas.microsoft.com/office/drawing/2014/main" val="1778836940"/>
                  </a:ext>
                </a:extLst>
              </a:tr>
              <a:tr h="333756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_C2</a:t>
                      </a:r>
                    </a:p>
                  </a:txBody>
                  <a:tcPr marL="82296" marR="82296" marT="41148" marB="41148"/>
                </a:tc>
                <a:tc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9</a:t>
                      </a:r>
                    </a:p>
                  </a:txBody>
                  <a:tcPr marL="82296" marR="82296" marT="41148" marB="41148"/>
                </a:tc>
                <a:extLst>
                  <a:ext uri="{0D108BD9-81ED-4DB2-BD59-A6C34878D82A}">
                    <a16:rowId xmlns:a16="http://schemas.microsoft.com/office/drawing/2014/main" val="1954436375"/>
                  </a:ext>
                </a:extLst>
              </a:tr>
              <a:tr h="333756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_C4</a:t>
                      </a:r>
                    </a:p>
                  </a:txBody>
                  <a:tcPr marL="82296" marR="82296" marT="41148" marB="41148"/>
                </a:tc>
                <a:tc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</a:t>
                      </a:r>
                    </a:p>
                  </a:txBody>
                  <a:tcPr marL="82296" marR="82296" marT="41148" marB="41148"/>
                </a:tc>
                <a:extLst>
                  <a:ext uri="{0D108BD9-81ED-4DB2-BD59-A6C34878D82A}">
                    <a16:rowId xmlns:a16="http://schemas.microsoft.com/office/drawing/2014/main" val="3234127843"/>
                  </a:ext>
                </a:extLst>
              </a:tr>
              <a:tr h="333756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_V3</a:t>
                      </a:r>
                    </a:p>
                  </a:txBody>
                  <a:tcPr marL="82296" marR="82296" marT="41148" marB="41148"/>
                </a:tc>
                <a:tc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</a:t>
                      </a:r>
                    </a:p>
                  </a:txBody>
                  <a:tcPr marL="82296" marR="82296" marT="41148" marB="41148"/>
                </a:tc>
                <a:extLst>
                  <a:ext uri="{0D108BD9-81ED-4DB2-BD59-A6C34878D82A}">
                    <a16:rowId xmlns:a16="http://schemas.microsoft.com/office/drawing/2014/main" val="12579867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3905324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0CD5F093-5039-2AF4-27CB-F197F0C148A2}"/>
              </a:ext>
            </a:extLst>
          </p:cNvPr>
          <p:cNvSpPr txBox="1"/>
          <p:nvPr/>
        </p:nvSpPr>
        <p:spPr>
          <a:xfrm>
            <a:off x="6477000" y="1263728"/>
            <a:ext cx="2393871" cy="26853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igure S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UMAP graph of top 5000 classical VHHs labeled with residue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t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IMGT 42 position (</a:t>
            </a: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 and number of cysteines (</a:t>
            </a: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 within sequences,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p 1000 non-classical VHHs labeled with types of mapped V genes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UMAP of classical and non-classical VHHs after removing non-assigned ones labeled with assigned types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  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nanoBERT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is used to generate sequence embeddings.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2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pic>
        <p:nvPicPr>
          <p:cNvPr id="7" name="Picture 6" descr="A screenshot of a graph&#10;&#10;Description automatically generated">
            <a:extLst>
              <a:ext uri="{FF2B5EF4-FFF2-40B4-BE49-F238E27FC236}">
                <a16:creationId xmlns:a16="http://schemas.microsoft.com/office/drawing/2014/main" id="{D0501A8E-2A41-0172-FBEF-561F5DEDBE1A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175" y="241178"/>
            <a:ext cx="5726453" cy="52326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3328547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0CD5F093-5039-2AF4-27CB-F197F0C148A2}"/>
              </a:ext>
            </a:extLst>
          </p:cNvPr>
          <p:cNvSpPr txBox="1"/>
          <p:nvPr/>
        </p:nvSpPr>
        <p:spPr>
          <a:xfrm>
            <a:off x="6522720" y="1199486"/>
            <a:ext cx="2349324" cy="25006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igure S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UMAP graph of top 5000 classical VHHs labeled with residue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t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IMGT 42 position (</a:t>
            </a: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 and number of cysteines (</a:t>
            </a: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 within sequences,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p 1000 non-classical VHHs labeled with types of mapped V genes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UMAP of classical and non-classical VHHs after removing non-assigned ones labeled with assigned types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 ESM2 is used to generate sequence embeddings.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2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pic>
        <p:nvPicPr>
          <p:cNvPr id="4" name="Picture 3" descr="A group of images of different colored dots&#10;&#10;Description automatically generated">
            <a:extLst>
              <a:ext uri="{FF2B5EF4-FFF2-40B4-BE49-F238E27FC236}">
                <a16:creationId xmlns:a16="http://schemas.microsoft.com/office/drawing/2014/main" id="{9A879730-29F5-3770-E0C6-70CAF173ADCC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1956" y="291829"/>
            <a:ext cx="5449958" cy="49854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11511685"/>
      </p:ext>
    </p:extLst>
  </p:cSld>
  <p:clrMapOvr>
    <a:masterClrMapping/>
  </p:clrMapOvr>
</p:sld>
</file>

<file path=ppt/theme/theme1.xml><?xml version="1.0" encoding="utf-8"?>
<a:theme xmlns:a="http://schemas.openxmlformats.org/drawingml/2006/main" name="webwppDef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wkzstkkp">
      <a:majorFont>
        <a:latin typeface="+mn-lt"/>
        <a:ea typeface="+mn-ea"/>
        <a:cs typeface=""/>
      </a:majorFont>
      <a:minorFont>
        <a:latin typeface="+mn-lt"/>
        <a:ea typeface="+mn-ea"/>
        <a:cs typeface="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4390</TotalTime>
  <Words>1016</Words>
  <Application>Microsoft Office PowerPoint</Application>
  <PresentationFormat>On-screen Show (16:10)</PresentationFormat>
  <Paragraphs>318</Paragraphs>
  <Slides>1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6</vt:i4>
      </vt:variant>
    </vt:vector>
  </HeadingPairs>
  <TitlesOfParts>
    <vt:vector size="23" baseType="lpstr">
      <vt:lpstr>等线</vt:lpstr>
      <vt:lpstr>微软雅黑</vt:lpstr>
      <vt:lpstr>Arial</vt:lpstr>
      <vt:lpstr>Calibri</vt:lpstr>
      <vt:lpstr>Times New Roman</vt:lpstr>
      <vt:lpstr>webwppDefTheme</vt:lpstr>
      <vt:lpstr>Office 主题​​</vt:lpstr>
      <vt:lpstr>PowerPoint Presentation</vt:lpstr>
      <vt:lpstr>PowerPoint Presentation</vt:lpstr>
      <vt:lpstr>Table S3: FR2 sequences in 17 VHH germlines of Alpaca</vt:lpstr>
      <vt:lpstr>Table S4: Top 5 germlines for classical and non-classical VHHs and corresponding types</vt:lpstr>
      <vt:lpstr>Table S5: Charge and hydropathy properties for top 5 germlines used in classical and non-classical VHHs</vt:lpstr>
      <vt:lpstr>Table S6: Sequences for two hinges used in Alpaca VHHs</vt:lpstr>
      <vt:lpstr>Table S7: Numbers of 4 types of VHHs in structure dataset</vt:lpstr>
      <vt:lpstr>PowerPoint Presentation</vt:lpstr>
      <vt:lpstr>PowerPoint Presentation</vt:lpstr>
      <vt:lpstr>PowerPoint Presentation</vt:lpstr>
      <vt:lpstr>PowerPoint Presentation</vt:lpstr>
      <vt:lpstr>Figure S5 Structure of F and Y.  These two amino acids are very similar, hydroxylation of F becomes Y.</vt:lpstr>
      <vt:lpstr>Figure S6 The comparison of epitope and paratope sizes based on the number of amino acids. Y_C2 VHHs showed slightly larger epitope and paratope size among 4 types of VHHs (A). VHHs using FR2 for binding showed significantly larger epitope and paratope sizes (B).</vt:lpstr>
      <vt:lpstr>Figure S7 Significant positive correlation (P&lt; 0.0001) was observed between CDR3 length and number of contact residues in CDR3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1</dc:creator>
  <cp:lastModifiedBy>Xinhao Wang</cp:lastModifiedBy>
  <cp:revision>1288</cp:revision>
  <dcterms:created xsi:type="dcterms:W3CDTF">2020-07-20T06:31:00Z</dcterms:created>
  <dcterms:modified xsi:type="dcterms:W3CDTF">2024-11-02T03:33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926</vt:lpwstr>
  </property>
</Properties>
</file>